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13651-5FD5-4382-BD4E-A366639465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9E8B1-1289-4602-8597-43271A60E2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34161F4-8989-4042-81E1-1EED74248F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71DDF78-1554-4CC2-AF3F-FE21A16324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E311593-37F3-4458-BC9E-714C3EA990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40D3DE5-666B-46A4-AF81-E23731E1D8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6DF9CFF-F766-4EA5-AF4F-D1006190C5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E092EB2-0B68-457D-84A0-C289B1EFB8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69883FB-0444-4758-AE52-8D088600A2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BA771DD-5107-4449-A26A-1B353EA894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3F914E3-9FED-48D3-9912-3C813B0576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80316BB-1763-4CDF-83B1-84481E37CF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E5FE2-BC61-4599-9413-0E64D186F3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1633586-166B-4E2A-A03E-EE4D265CE7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D5FE26B-1F73-431A-A5D5-AA7CF19125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4BDD6CC-B017-4424-86CF-B35FAB9C00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4F4555E-5383-4572-A3B8-FCF904A8CD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40F9C56-1D4B-4542-9DA7-8CDAD9A88F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054BB3F-8C37-4B34-982C-688000B4B1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266636E-2445-4B42-ABA0-8AA0FC4760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A4A1163-89F4-4F23-865B-62320E4AFC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464191A-831E-43D5-8A63-68BB80ADF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26CED1A-84AA-424D-8189-BEB25084C3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1AC54-38C3-400A-ABB0-0605F632EA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A0AEB83-B202-4D80-88D6-816A079253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9D6FA10-F376-454F-BD2D-3BC4E15747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7019746-6338-49B7-92CF-B115DD9F66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30BEFC9-968D-401A-9020-2FA0876A53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3850A63-FA71-4364-ACCC-BCC9985914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5475ECF-7B88-4BF4-8115-5615E271E0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450BC61-F0CC-4F63-8A2D-DA8609EAF7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B08445D-7E5F-4101-8AC4-81243F69C7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C3415CE-EE0C-474D-AE43-F79A03969C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6A0D929-351B-4EFE-BD86-110542C28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239882-B561-4E1F-AD3F-C312FFDD85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CC59ABB-7443-47E4-B505-AF821787DF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5EF522C-D4C8-4FBB-8933-423B2C3D8C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08BD9FA-D921-4588-8390-597F384486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16065F-C47B-42B4-97A1-C3E2BFE376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FD30F19-2E7B-4BF7-93A9-CAE8FABA35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BCE3D3-76F6-4862-AE6A-56CAB9A04A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0FDDA8-27AD-47BB-9E28-13C4BA646D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857EC4-4A99-4167-A4E5-14A4B9AB74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739B82D-CE72-4E68-828B-A2163A383F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F74B0-AD93-4672-BD84-AEC3B35E17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6A0BF09-AA75-4E79-9CD6-442720B064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218790-1653-4FE6-A6FC-8EB62B6DA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D11AF1C-3EA3-45F1-AC1F-1511EDB8D0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0096CD3-0C3A-4AA2-88CD-A0DE24A83B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8F1BDB-1A06-4C98-AC16-2BCA507F18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B12FDF4-509E-4CE0-960F-279F778E51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6A263BD-391F-431E-9AEC-D3D06CBDEA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1742823-6504-4C46-BB6A-823ACA2ED2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F4B474C-17D0-48D5-A709-2128E6B8E1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1052877-D11B-4C91-9D22-647E400A0E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11C9D-0CD6-43DE-8D60-6BF2AEFFED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B89B039-DD36-43A7-8D57-4DB96863A0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6DE1864-84C4-4D86-B24D-8F749AA41B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D8958BD-07D6-4AAC-A189-BD9216CA4B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B3FDAB1-67D9-4FE4-9ECF-6FA05B0967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E34450-E96D-4757-8D08-C3E66A3B85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B45D049-09C9-4BBA-9DCC-7653C60C5F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18F4A0-9042-4195-A0AE-5C4A162B2E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4AAA212-D95A-4606-93C3-080EE4BB1A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D9DA80A-8571-4FEE-9572-3F5567FA6D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757E27A-5686-4C31-888D-806C5282F8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EFAB6-897F-4694-B907-9648D5B8B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0792676-2B16-43B7-A667-9F597957F3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1B7E418-C722-4255-B02A-F50C8D4135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A465AB6-1DEA-4DFA-82DF-927DB58864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8AA3F3B-0C30-4E5E-BBCC-75A7369927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E1C0C2A-6AE4-47EE-951C-A36FF1075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9EBDB2A-6CA1-4BD9-9DB8-0EDCA0EC95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36C6EA4-7AD2-4583-A779-EEC9915917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610C012-5BEA-4A1A-8043-552BC78E76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74F3331-E70B-41D5-9409-50C23B0384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D4554A3-E966-4E44-A095-9BBF6CE604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99505-0A57-499B-B789-62858825AD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837DAB4-A350-4BB8-BE59-74E95590A2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30C1588-ECF7-4471-95C7-4AE0827447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F84BE6A-92BF-4CBE-B27F-9B6807BDBA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1B5BBFD-F86C-46C6-B480-196D6B6A75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8143236-BFE8-4870-8060-2B63A92274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650A3D0-EB80-4496-ACCD-A13112D45D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26273F4-FEAC-445C-9D10-55F6DEAC16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FCA17C2-46F9-4F0F-85D0-4A147DAECA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AA8D630-4B54-4C8F-BC63-85D5795430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ED13D01-2548-48DE-9CF7-BF49579FA1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F7D49-6184-4B32-AD8F-8FD273B967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93F60A4-8BA1-418F-8D2E-D403E28880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AB54354-9F3A-44FD-8B3D-5E9AF30EAA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DC93B8C-4F88-4FF1-89F2-610163E38F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89823B4-46E0-41A0-AB28-88D5BC8AC8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4A5A96E-405D-4C5E-987C-BEED72D6DA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D0A2136-7A08-4A6C-9DC4-B7B0DCFB3E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DF868D0-98F0-4D37-A46E-F9E4475405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F87EC63-54F8-4E35-BDE2-DBFCA6A9B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ED43609-7ECA-413D-B97C-109E333AE1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0D48A77-066E-4174-AF17-ABD2EF44E1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50677-021E-4570-9900-1F7E066FCC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5DAC37E-5C06-4A19-84E7-A72D4491C4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63E6A56-0987-40C0-B189-D0812EAF9D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B38183B-D6F0-46ED-A32E-1D9D455C23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915CBE2-C0F5-4E6E-93C5-C0669C920F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9B287FD-0C4D-400F-839F-1DE70DDE78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57F171A-4D59-473C-98A7-046B198195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6BFFB7F-8E14-48D4-84A1-06597BD6C5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92368F3-00A0-481F-B3BF-7FDEE3EB9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C7ADBB1-07AA-4178-BF7A-52BE3EBD58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C712459-5BD9-4E93-85BA-FBB892CAD8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34F8B-8BD7-4745-BF96-D4BC7827D7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9684478-99C6-417E-A66A-7810E355CB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E8E7C2B-3C44-4D0F-8C1A-020168D676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280B0CD-870B-4EC7-B7DE-8CA757077C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88D4B5A-9DA2-4C66-946C-4290FB5BFB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05321A0-B518-4F5B-8CF2-A3CCB85D13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CA83869-A4CF-4121-A051-D9C1F5793E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EEFF59E-F68A-4477-A797-AAEC941B7C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0979ECB-A653-4EEE-A9D7-855DDECEF5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DEEA477-B10E-4B07-A8AF-47B0F2E866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A68BB9E-5C24-40E9-A6D0-38FAC832D0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94ED8-1E6F-47D4-B389-5DB00349C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C541A7A-1CCD-479D-A8FE-605CF2850A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393BA7A-FDE4-47AE-A581-C859D82BC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5817707-047A-44C9-91CF-A718D01188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520BEC6-69A6-47A9-91F7-1B8BE8ABA3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2D944ED-FAF7-4EE2-A71A-2BCAE9BC75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ED0015B-D7DC-4D12-A637-34BC562E9D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49C7F78-D691-41E7-BEF9-FD8A1D6A08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EBBB305-655B-40A9-AF51-E452998ADC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1F5F32D-57C4-4E30-AD41-1F6633FCDA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3CDC9B6-1FE9-4CED-A5D4-BAFF1382B8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104282-271D-4C7F-A9C3-2A1E9FFF39A3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 type="dt" idx="28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2" name="PlaceHolder 4"/>
          <p:cNvSpPr>
            <a:spLocks noGrp="1"/>
          </p:cNvSpPr>
          <p:nvPr>
            <p:ph type="ftr" idx="29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PlaceHolder 5"/>
          <p:cNvSpPr>
            <a:spLocks noGrp="1"/>
          </p:cNvSpPr>
          <p:nvPr>
            <p:ph type="sldNum" idx="30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1DDCF3-9590-4E3E-97BC-FBA5FCA052D8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PlaceHolder 3"/>
          <p:cNvSpPr>
            <a:spLocks noGrp="1"/>
          </p:cNvSpPr>
          <p:nvPr>
            <p:ph type="dt" idx="3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4" name="PlaceHolder 4"/>
          <p:cNvSpPr>
            <a:spLocks noGrp="1"/>
          </p:cNvSpPr>
          <p:nvPr>
            <p:ph type="ftr" idx="3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5"/>
          <p:cNvSpPr>
            <a:spLocks noGrp="1"/>
          </p:cNvSpPr>
          <p:nvPr>
            <p:ph type="sldNum" idx="3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31FA8B-9CE1-4CF2-8D73-EC1FD1F373CE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Title Placeholder 1"/>
          <p:cNvSpPr/>
          <p:nvPr/>
        </p:nvSpPr>
        <p:spPr>
          <a:xfrm>
            <a:off x="457200" y="351000"/>
            <a:ext cx="8229600" cy="102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3000" spc="-1" strike="noStrike">
                <a:solidFill>
                  <a:srgbClr val="000000"/>
                </a:solidFill>
                <a:latin typeface="Times New Roman"/>
              </a:rPr>
              <a:t>SCM6 White Label Figure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Footer Placeholder 4"/>
          <p:cNvSpPr/>
          <p:nvPr/>
        </p:nvSpPr>
        <p:spPr>
          <a:xfrm>
            <a:off x="3124080" y="6248520"/>
            <a:ext cx="38862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Copyright © The Publisher. All rights re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 type="dt" idx="3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4F8408-B3A8-4E53-8222-61919144E258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30178C-23E6-4298-BD49-A6E9D1D2C928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 type="dt" idx="10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 type="ftr" idx="11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5"/>
          <p:cNvSpPr>
            <a:spLocks noGrp="1"/>
          </p:cNvSpPr>
          <p:nvPr>
            <p:ph type="sldNum" idx="12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E22FAA-E2C1-40C3-AB97-80A90A013889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laceHolder 3"/>
          <p:cNvSpPr>
            <a:spLocks noGrp="1"/>
          </p:cNvSpPr>
          <p:nvPr>
            <p:ph type="dt" idx="1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PlaceHolder 4"/>
          <p:cNvSpPr>
            <a:spLocks noGrp="1"/>
          </p:cNvSpPr>
          <p:nvPr>
            <p:ph type="ftr" idx="14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PlaceHolder 5"/>
          <p:cNvSpPr>
            <a:spLocks noGrp="1"/>
          </p:cNvSpPr>
          <p:nvPr>
            <p:ph type="sldNum" idx="15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864631-E1A7-4F5A-A0B1-B3C9A22458EE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 type="dt" idx="16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 type="ftr" idx="17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 type="sldNum" idx="18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0DEE0E-64FD-4989-9EA1-2A24F2C0826F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 type="dt" idx="19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 type="ftr" idx="20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 type="sldNum" idx="2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2882A4-C560-456C-A951-B03733740EA0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3"/>
          <p:cNvSpPr>
            <a:spLocks noGrp="1"/>
          </p:cNvSpPr>
          <p:nvPr>
            <p:ph type="dt" idx="22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8" name="PlaceHolder 4"/>
          <p:cNvSpPr>
            <a:spLocks noGrp="1"/>
          </p:cNvSpPr>
          <p:nvPr>
            <p:ph type="ftr" idx="23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PlaceHolder 5"/>
          <p:cNvSpPr>
            <a:spLocks noGrp="1"/>
          </p:cNvSpPr>
          <p:nvPr>
            <p:ph type="sldNum" idx="24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8369F5-1067-4ED7-AC73-59CA9044A0EB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 type="dt" idx="25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Date of download:  mm/dd/yyy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 type="ftr" idx="26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 type="sldNum" idx="27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20C13C-59A2-4F24-8444-4AADE00899EF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Date Placeholder 3"/>
          <p:cNvSpPr/>
          <p:nvPr/>
        </p:nvSpPr>
        <p:spPr>
          <a:xfrm>
            <a:off x="457200" y="6400800"/>
            <a:ext cx="213372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898989"/>
                </a:solidFill>
                <a:latin typeface="Arial"/>
              </a:rPr>
              <a:t>Date of download:  9/24/201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Footer Placeholder 4"/>
          <p:cNvSpPr/>
          <p:nvPr/>
        </p:nvSpPr>
        <p:spPr>
          <a:xfrm>
            <a:off x="2514600" y="6324480"/>
            <a:ext cx="58672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Text Placeholder 2"/>
          <p:cNvSpPr/>
          <p:nvPr/>
        </p:nvSpPr>
        <p:spPr>
          <a:xfrm>
            <a:off x="304920" y="735120"/>
            <a:ext cx="822960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rom: PRISMA Extension for Scoping Reviews (PRISMA-ScR): Checklist and Explan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Straight Connector 8"/>
          <p:cNvSpPr/>
          <p:nvPr/>
        </p:nvSpPr>
        <p:spPr>
          <a:xfrm>
            <a:off x="380880" y="6248520"/>
            <a:ext cx="8382240" cy="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Text Placeholder 2"/>
          <p:cNvSpPr/>
          <p:nvPr/>
        </p:nvSpPr>
        <p:spPr>
          <a:xfrm>
            <a:off x="304920" y="1344600"/>
            <a:ext cx="8381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nn Intern Med. Published online  September 04, 2018. doi:10.7326/M18-08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Text Placeholder 2"/>
          <p:cNvSpPr/>
          <p:nvPr/>
        </p:nvSpPr>
        <p:spPr>
          <a:xfrm>
            <a:off x="1828800" y="1420920"/>
            <a:ext cx="7086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Text Placeholder 2"/>
          <p:cNvSpPr/>
          <p:nvPr/>
        </p:nvSpPr>
        <p:spPr>
          <a:xfrm>
            <a:off x="609480" y="5562720"/>
            <a:ext cx="81536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TextBox 11"/>
          <p:cNvSpPr/>
          <p:nvPr/>
        </p:nvSpPr>
        <p:spPr>
          <a:xfrm>
            <a:off x="609480" y="5286240"/>
            <a:ext cx="1828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Straight Connector 14"/>
          <p:cNvSpPr/>
          <p:nvPr/>
        </p:nvSpPr>
        <p:spPr>
          <a:xfrm>
            <a:off x="380880" y="1752480"/>
            <a:ext cx="8382240" cy="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TextBox 11"/>
          <p:cNvSpPr/>
          <p:nvPr/>
        </p:nvSpPr>
        <p:spPr>
          <a:xfrm>
            <a:off x="3809880" y="6400800"/>
            <a:ext cx="42530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7f7f7f"/>
                </a:solidFill>
                <a:latin typeface="Arial"/>
              </a:rPr>
              <a:t>Copyright © American College of Physicians.  All rights reserved</a:t>
            </a:r>
            <a:r>
              <a:rPr b="0" lang="en-US" sz="1500" spc="-1" strike="noStrike">
                <a:solidFill>
                  <a:srgbClr val="c2d1e2"/>
                </a:solidFill>
                <a:latin typeface="Arial"/>
              </a:rPr>
              <a:t>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4" name="Picture 1" descr=""/>
          <p:cNvPicPr/>
          <p:nvPr/>
        </p:nvPicPr>
        <p:blipFill>
          <a:blip r:embed="rId1"/>
          <a:stretch/>
        </p:blipFill>
        <p:spPr>
          <a:xfrm>
            <a:off x="380880" y="106200"/>
            <a:ext cx="3256200" cy="247680"/>
          </a:xfrm>
          <a:prstGeom prst="rect">
            <a:avLst/>
          </a:prstGeom>
          <a:ln w="0">
            <a:noFill/>
          </a:ln>
        </p:spPr>
      </p:pic>
      <p:pic>
        <p:nvPicPr>
          <p:cNvPr id="515" name="" descr=""/>
          <p:cNvPicPr/>
          <p:nvPr/>
        </p:nvPicPr>
        <p:blipFill>
          <a:blip r:embed="rId2"/>
          <a:stretch/>
        </p:blipFill>
        <p:spPr>
          <a:xfrm>
            <a:off x="3381480" y="2057400"/>
            <a:ext cx="2379600" cy="308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Billy Chorey</cp:lastModifiedBy>
  <dcterms:modified xsi:type="dcterms:W3CDTF">2016-06-01T19:04:21Z</dcterms:modified>
  <cp:revision>55</cp:revision>
  <dc:subject/>
  <dc:title>Slide 1</dc:title>
</cp:coreProperties>
</file>